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1-Borriss\Documents\PAPER,%20PATENTE\2013\Soumitra_2013\submission%202\Suppl.mat\Suppl.Fig.9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1-Borriss\Documents\PAPER,%20PATENTE\2013\Soumitra_2013\submission%202\Suppl.mat\Suppl.Fig.9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de-DE"/>
  <c:chart>
    <c:autoTitleDeleted val="1"/>
    <c:plotArea>
      <c:layout/>
      <c:barChart>
        <c:barDir val="col"/>
        <c:grouping val="clustered"/>
        <c:ser>
          <c:idx val="0"/>
          <c:order val="0"/>
          <c:tx>
            <c:v>-T</c:v>
          </c:tx>
          <c:errBars>
            <c:errBarType val="both"/>
            <c:errValType val="cust"/>
            <c:plus>
              <c:numRef>
                <c:f>('13-11-13-bacterail-extracts-2-I'!$J$20,'13-11-13-bacterail-extracts-2-I'!$L$20,'13-11-13-bacterail-extracts-2-I'!$N$20,'13-11-13-bacterail-extracts-2-I'!$P$20,'13-11-13-bacterail-extracts-2-I'!$R$20)</c:f>
                <c:numCache>
                  <c:formatCode>General</c:formatCode>
                  <c:ptCount val="5"/>
                  <c:pt idx="0">
                    <c:v>1.7863945386305755</c:v>
                  </c:pt>
                  <c:pt idx="1">
                    <c:v>0.82962236674119361</c:v>
                  </c:pt>
                  <c:pt idx="2">
                    <c:v>2.4062381809601177</c:v>
                  </c:pt>
                  <c:pt idx="3">
                    <c:v>4.4480148526826628</c:v>
                  </c:pt>
                  <c:pt idx="4">
                    <c:v>0</c:v>
                  </c:pt>
                </c:numCache>
              </c:numRef>
            </c:plus>
            <c:minus>
              <c:numRef>
                <c:f>('13-11-13-bacterail-extracts-2-I'!$J$20,'13-11-13-bacterail-extracts-2-I'!$L$20,'13-11-13-bacterail-extracts-2-I'!$N$20,'13-11-13-bacterail-extracts-2-I'!$P$20,'13-11-13-bacterail-extracts-2-I'!$R$20)</c:f>
                <c:numCache>
                  <c:formatCode>General</c:formatCode>
                  <c:ptCount val="5"/>
                  <c:pt idx="0">
                    <c:v>1.7863945386305755</c:v>
                  </c:pt>
                  <c:pt idx="1">
                    <c:v>0.82962236674119361</c:v>
                  </c:pt>
                  <c:pt idx="2">
                    <c:v>2.4062381809601177</c:v>
                  </c:pt>
                  <c:pt idx="3">
                    <c:v>4.4480148526826628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13-11-13-bacterail-extracts-2-I'!$I$27:$I$31</c:f>
              <c:strCache>
                <c:ptCount val="5"/>
                <c:pt idx="0">
                  <c:v>FZB42</c:v>
                </c:pt>
                <c:pt idx="1">
                  <c:v>nrfA</c:v>
                </c:pt>
                <c:pt idx="2">
                  <c:v>degU</c:v>
                </c:pt>
                <c:pt idx="3">
                  <c:v>rBAM</c:v>
                </c:pt>
                <c:pt idx="4">
                  <c:v>Landy</c:v>
                </c:pt>
              </c:strCache>
            </c:strRef>
          </c:cat>
          <c:val>
            <c:numRef>
              <c:f>('13-11-13-bacterail-extracts-2-I'!$J$19,'13-11-13-bacterail-extracts-2-I'!$L$19,'13-11-13-bacterail-extracts-2-I'!$N$19,'13-11-13-bacterail-extracts-2-I'!$P$19,'13-11-13-bacterail-extracts-2-I'!$R$19)</c:f>
              <c:numCache>
                <c:formatCode>0.00E+00</c:formatCode>
                <c:ptCount val="5"/>
                <c:pt idx="0">
                  <c:v>14.702395859997624</c:v>
                </c:pt>
                <c:pt idx="1">
                  <c:v>9.0083342954994823</c:v>
                </c:pt>
                <c:pt idx="2">
                  <c:v>11.323834116598489</c:v>
                </c:pt>
                <c:pt idx="3">
                  <c:v>22.899173563946771</c:v>
                </c:pt>
                <c:pt idx="4">
                  <c:v>6.6228070175438578</c:v>
                </c:pt>
              </c:numCache>
            </c:numRef>
          </c:val>
        </c:ser>
        <c:ser>
          <c:idx val="1"/>
          <c:order val="1"/>
          <c:tx>
            <c:v>+T</c:v>
          </c:tx>
          <c:errBars>
            <c:errBarType val="both"/>
            <c:errValType val="cust"/>
            <c:plus>
              <c:numRef>
                <c:f>('13-11-13-bacterail-extracts-2-I'!$K$20,'13-11-13-bacterail-extracts-2-I'!$M$20,'13-11-13-bacterail-extracts-2-I'!$O$20,'13-11-13-bacterail-extracts-2-I'!$Q$20,'13-11-13-bacterail-extracts-2-I'!$S$20)</c:f>
                <c:numCache>
                  <c:formatCode>General</c:formatCode>
                  <c:ptCount val="5"/>
                  <c:pt idx="0">
                    <c:v>27.932803084326174</c:v>
                  </c:pt>
                  <c:pt idx="1">
                    <c:v>35.7984898235459</c:v>
                  </c:pt>
                  <c:pt idx="2">
                    <c:v>43.472837363914458</c:v>
                  </c:pt>
                  <c:pt idx="3">
                    <c:v>92.292889951813464</c:v>
                  </c:pt>
                  <c:pt idx="4">
                    <c:v>0</c:v>
                  </c:pt>
                </c:numCache>
              </c:numRef>
            </c:plus>
            <c:minus>
              <c:numRef>
                <c:f>('13-11-13-bacterail-extracts-2-I'!$K$20,'13-11-13-bacterail-extracts-2-I'!$M$20,'13-11-13-bacterail-extracts-2-I'!$O$20,'13-11-13-bacterail-extracts-2-I'!$Q$20,'13-11-13-bacterail-extracts-2-I'!$S$20)</c:f>
                <c:numCache>
                  <c:formatCode>General</c:formatCode>
                  <c:ptCount val="5"/>
                  <c:pt idx="0">
                    <c:v>27.932803084326174</c:v>
                  </c:pt>
                  <c:pt idx="1">
                    <c:v>35.7984898235459</c:v>
                  </c:pt>
                  <c:pt idx="2">
                    <c:v>43.472837363914458</c:v>
                  </c:pt>
                  <c:pt idx="3">
                    <c:v>92.292889951813464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13-11-13-bacterail-extracts-2-I'!$I$27:$I$31</c:f>
              <c:strCache>
                <c:ptCount val="5"/>
                <c:pt idx="0">
                  <c:v>FZB42</c:v>
                </c:pt>
                <c:pt idx="1">
                  <c:v>nrfA</c:v>
                </c:pt>
                <c:pt idx="2">
                  <c:v>degU</c:v>
                </c:pt>
                <c:pt idx="3">
                  <c:v>rBAM</c:v>
                </c:pt>
                <c:pt idx="4">
                  <c:v>Landy</c:v>
                </c:pt>
              </c:strCache>
            </c:strRef>
          </c:cat>
          <c:val>
            <c:numRef>
              <c:f>('13-11-13-bacterail-extracts-2-I'!$K$19,'13-11-13-bacterail-extracts-2-I'!$M$19,'13-11-13-bacterail-extracts-2-I'!$O$19,'13-11-13-bacterail-extracts-2-I'!$Q$19,'13-11-13-bacterail-extracts-2-I'!$S$19)</c:f>
              <c:numCache>
                <c:formatCode>0.00E+00</c:formatCode>
                <c:ptCount val="5"/>
                <c:pt idx="0">
                  <c:v>159.08808342106053</c:v>
                </c:pt>
                <c:pt idx="1">
                  <c:v>159.9417435201652</c:v>
                </c:pt>
                <c:pt idx="2">
                  <c:v>261.08620432963158</c:v>
                </c:pt>
                <c:pt idx="3">
                  <c:v>241.70875866167015</c:v>
                </c:pt>
                <c:pt idx="4">
                  <c:v>3.4502923976608177</c:v>
                </c:pt>
              </c:numCache>
            </c:numRef>
          </c:val>
        </c:ser>
        <c:axId val="69749376"/>
        <c:axId val="71164288"/>
      </c:barChart>
      <c:catAx>
        <c:axId val="69749376"/>
        <c:scaling>
          <c:orientation val="minMax"/>
        </c:scaling>
        <c:axPos val="b"/>
        <c:numFmt formatCode="General" sourceLinked="1"/>
        <c:tickLblPos val="nextTo"/>
        <c:crossAx val="71164288"/>
        <c:crosses val="autoZero"/>
        <c:auto val="1"/>
        <c:lblAlgn val="ctr"/>
        <c:lblOffset val="100"/>
      </c:catAx>
      <c:valAx>
        <c:axId val="71164288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ng / ml medium</a:t>
                </a:r>
              </a:p>
            </c:rich>
          </c:tx>
          <c:layout/>
        </c:title>
        <c:numFmt formatCode="0.00E+00" sourceLinked="1"/>
        <c:tickLblPos val="nextTo"/>
        <c:crossAx val="69749376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de-DE"/>
  <c:chart>
    <c:title>
      <c:tx>
        <c:rich>
          <a:bodyPr/>
          <a:lstStyle/>
          <a:p>
            <a:pPr>
              <a:defRPr/>
            </a:pPr>
            <a:r>
              <a:rPr lang="de-DE" dirty="0"/>
              <a:t>-</a:t>
            </a:r>
            <a:r>
              <a:rPr lang="de-DE" dirty="0" err="1" smtClean="0"/>
              <a:t>Trp</a:t>
            </a:r>
            <a:endParaRPr lang="de-DE" dirty="0"/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v>-T</c:v>
          </c:tx>
          <c:errBars>
            <c:errBarType val="both"/>
            <c:errValType val="cust"/>
            <c:plus>
              <c:numRef>
                <c:f>('13-11-13-bacterail-extracts-2-I'!$J$20,'13-11-13-bacterail-extracts-2-I'!$L$20,'13-11-13-bacterail-extracts-2-I'!$N$20,'13-11-13-bacterail-extracts-2-I'!$P$20,'13-11-13-bacterail-extracts-2-I'!$R$20)</c:f>
                <c:numCache>
                  <c:formatCode>General</c:formatCode>
                  <c:ptCount val="5"/>
                  <c:pt idx="0">
                    <c:v>1.7863945386305751</c:v>
                  </c:pt>
                  <c:pt idx="1">
                    <c:v>0.82962236674119361</c:v>
                  </c:pt>
                  <c:pt idx="2">
                    <c:v>2.4062381809601177</c:v>
                  </c:pt>
                  <c:pt idx="3">
                    <c:v>4.4480148526826628</c:v>
                  </c:pt>
                  <c:pt idx="4">
                    <c:v>0</c:v>
                  </c:pt>
                </c:numCache>
              </c:numRef>
            </c:plus>
            <c:minus>
              <c:numRef>
                <c:f>('13-11-13-bacterail-extracts-2-I'!$J$20,'13-11-13-bacterail-extracts-2-I'!$L$20,'13-11-13-bacterail-extracts-2-I'!$N$20,'13-11-13-bacterail-extracts-2-I'!$P$20,'13-11-13-bacterail-extracts-2-I'!$R$20)</c:f>
                <c:numCache>
                  <c:formatCode>General</c:formatCode>
                  <c:ptCount val="5"/>
                  <c:pt idx="0">
                    <c:v>1.7863945386305751</c:v>
                  </c:pt>
                  <c:pt idx="1">
                    <c:v>0.82962236674119361</c:v>
                  </c:pt>
                  <c:pt idx="2">
                    <c:v>2.4062381809601177</c:v>
                  </c:pt>
                  <c:pt idx="3">
                    <c:v>4.4480148526826628</c:v>
                  </c:pt>
                  <c:pt idx="4">
                    <c:v>0</c:v>
                  </c:pt>
                </c:numCache>
              </c:numRef>
            </c:minus>
          </c:errBars>
          <c:cat>
            <c:strRef>
              <c:f>'13-11-13-bacterail-extracts-2-I'!$I$27:$I$31</c:f>
              <c:strCache>
                <c:ptCount val="5"/>
                <c:pt idx="0">
                  <c:v>FZB42</c:v>
                </c:pt>
                <c:pt idx="1">
                  <c:v>nrfA</c:v>
                </c:pt>
                <c:pt idx="2">
                  <c:v>degU</c:v>
                </c:pt>
                <c:pt idx="3">
                  <c:v>rBAM</c:v>
                </c:pt>
                <c:pt idx="4">
                  <c:v>Landy</c:v>
                </c:pt>
              </c:strCache>
            </c:strRef>
          </c:cat>
          <c:val>
            <c:numRef>
              <c:f>('13-11-13-bacterail-extracts-2-I'!$J$19,'13-11-13-bacterail-extracts-2-I'!$L$19,'13-11-13-bacterail-extracts-2-I'!$N$19,'13-11-13-bacterail-extracts-2-I'!$P$19,'13-11-13-bacterail-extracts-2-I'!$R$19)</c:f>
              <c:numCache>
                <c:formatCode>0.00E+00</c:formatCode>
                <c:ptCount val="5"/>
                <c:pt idx="0">
                  <c:v>14.702395859997624</c:v>
                </c:pt>
                <c:pt idx="1">
                  <c:v>9.0083342954994823</c:v>
                </c:pt>
                <c:pt idx="2">
                  <c:v>11.323834116598489</c:v>
                </c:pt>
                <c:pt idx="3">
                  <c:v>22.899173563946771</c:v>
                </c:pt>
                <c:pt idx="4">
                  <c:v>6.6228070175438578</c:v>
                </c:pt>
              </c:numCache>
            </c:numRef>
          </c:val>
        </c:ser>
        <c:axId val="72233344"/>
        <c:axId val="72234880"/>
      </c:barChart>
      <c:catAx>
        <c:axId val="72233344"/>
        <c:scaling>
          <c:orientation val="minMax"/>
        </c:scaling>
        <c:axPos val="b"/>
        <c:numFmt formatCode="General" sourceLinked="1"/>
        <c:tickLblPos val="nextTo"/>
        <c:crossAx val="72234880"/>
        <c:crosses val="autoZero"/>
        <c:auto val="1"/>
        <c:lblAlgn val="ctr"/>
        <c:lblOffset val="100"/>
      </c:catAx>
      <c:valAx>
        <c:axId val="72234880"/>
        <c:scaling>
          <c:orientation val="minMax"/>
        </c:scaling>
        <c:axPos val="l"/>
        <c:majorGridlines/>
        <c:numFmt formatCode="0.00E+00" sourceLinked="1"/>
        <c:tickLblPos val="nextTo"/>
        <c:crossAx val="72233344"/>
        <c:crosses val="autoZero"/>
        <c:crossBetween val="between"/>
      </c:valAx>
    </c:plotArea>
    <c:legend>
      <c:legendPos val="r"/>
      <c:layout/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4F659-1120-4347-9B55-2D3237F16037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EB621-9DBB-4E63-8E1E-7C3B7F6BE56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1"/>
          <p:cNvGraphicFramePr>
            <a:graphicFrameLocks/>
          </p:cNvGraphicFramePr>
          <p:nvPr/>
        </p:nvGraphicFramePr>
        <p:xfrm>
          <a:off x="1268760" y="89959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2"/>
          <p:cNvGraphicFramePr>
            <a:graphicFrameLocks/>
          </p:cNvGraphicFramePr>
          <p:nvPr/>
        </p:nvGraphicFramePr>
        <p:xfrm>
          <a:off x="1412776" y="406794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/>
        </p:nvGraphicFramePr>
        <p:xfrm>
          <a:off x="1196752" y="3707904"/>
          <a:ext cx="4571996" cy="389658"/>
        </p:xfrm>
        <a:graphic>
          <a:graphicData uri="http://schemas.openxmlformats.org/drawingml/2006/table">
            <a:tbl>
              <a:tblPr/>
              <a:tblGrid>
                <a:gridCol w="415636"/>
                <a:gridCol w="415636"/>
                <a:gridCol w="415636"/>
                <a:gridCol w="415636"/>
                <a:gridCol w="415636"/>
                <a:gridCol w="415636"/>
                <a:gridCol w="415636"/>
                <a:gridCol w="415636"/>
                <a:gridCol w="415636"/>
                <a:gridCol w="415636"/>
                <a:gridCol w="415636"/>
              </a:tblGrid>
              <a:tr h="129886"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AV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47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59E+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01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60E+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13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61E+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9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2E+0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,62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45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86"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S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79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79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,30E-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58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41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,35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,45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23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#DIV/0!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#DIV/0!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29886">
                <a:tc>
                  <a:txBody>
                    <a:bodyPr/>
                    <a:lstStyle/>
                    <a:p>
                      <a:pPr algn="l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%SD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22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76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,21E+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24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,12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67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,94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,82E+0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#DIV/0!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7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#DIV/0!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1124744" y="7236296"/>
            <a:ext cx="489654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Figure</a:t>
            </a:r>
            <a:r>
              <a:rPr lang="de-DE" sz="1400" b="1" dirty="0" smtClean="0"/>
              <a:t> </a:t>
            </a:r>
            <a:r>
              <a:rPr lang="de-DE" sz="1400" b="1" dirty="0" smtClean="0"/>
              <a:t>S10</a:t>
            </a:r>
            <a:r>
              <a:rPr lang="de-DE" sz="1400" dirty="0" smtClean="0"/>
              <a:t>. </a:t>
            </a:r>
            <a:r>
              <a:rPr lang="de-DE" sz="1400" dirty="0" smtClean="0"/>
              <a:t>IAA </a:t>
            </a:r>
            <a:r>
              <a:rPr lang="de-DE" sz="1400" dirty="0" err="1" smtClean="0"/>
              <a:t>production</a:t>
            </a:r>
            <a:r>
              <a:rPr lang="de-DE" sz="1400" dirty="0" smtClean="0"/>
              <a:t> </a:t>
            </a:r>
            <a:r>
              <a:rPr lang="de-DE" sz="1400" dirty="0" err="1" smtClean="0"/>
              <a:t>of</a:t>
            </a:r>
            <a:r>
              <a:rPr lang="de-DE" sz="1400" dirty="0" smtClean="0"/>
              <a:t> FZB42 </a:t>
            </a:r>
            <a:r>
              <a:rPr lang="de-DE" sz="1400" dirty="0" err="1" smtClean="0"/>
              <a:t>and</a:t>
            </a:r>
            <a:r>
              <a:rPr lang="de-DE" sz="1400" dirty="0" smtClean="0"/>
              <a:t> nrfA, degU, </a:t>
            </a:r>
            <a:r>
              <a:rPr lang="de-DE" sz="1400" dirty="0" err="1" smtClean="0"/>
              <a:t>and</a:t>
            </a:r>
            <a:r>
              <a:rPr lang="de-DE" sz="1400" dirty="0" smtClean="0"/>
              <a:t> RBAM_17410 (</a:t>
            </a:r>
            <a:r>
              <a:rPr lang="de-DE" sz="1400" dirty="0" err="1" smtClean="0"/>
              <a:t>rBAM</a:t>
            </a:r>
            <a:r>
              <a:rPr lang="de-DE" sz="1400" dirty="0" smtClean="0"/>
              <a:t>) </a:t>
            </a:r>
            <a:r>
              <a:rPr lang="de-DE" sz="1400" dirty="0" err="1" smtClean="0"/>
              <a:t>mutant</a:t>
            </a:r>
            <a:r>
              <a:rPr lang="de-DE" sz="1400" dirty="0" smtClean="0"/>
              <a:t> </a:t>
            </a:r>
            <a:r>
              <a:rPr lang="de-DE" sz="1400" dirty="0" err="1" smtClean="0"/>
              <a:t>strains</a:t>
            </a:r>
            <a:r>
              <a:rPr lang="de-DE" sz="1400" dirty="0" smtClean="0"/>
              <a:t> in </a:t>
            </a:r>
            <a:r>
              <a:rPr lang="de-DE" sz="1400" dirty="0" err="1" smtClean="0"/>
              <a:t>absence</a:t>
            </a:r>
            <a:r>
              <a:rPr lang="de-DE" sz="1400" dirty="0" smtClean="0"/>
              <a:t> (-T)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presence</a:t>
            </a:r>
            <a:r>
              <a:rPr lang="de-DE" sz="1400" dirty="0" smtClean="0"/>
              <a:t> (+T) </a:t>
            </a:r>
            <a:r>
              <a:rPr lang="de-DE" sz="1400" dirty="0" err="1" smtClean="0"/>
              <a:t>of</a:t>
            </a:r>
            <a:r>
              <a:rPr lang="de-DE" sz="1400" dirty="0" smtClean="0"/>
              <a:t> </a:t>
            </a:r>
            <a:r>
              <a:rPr lang="de-DE" sz="1400" dirty="0" err="1" smtClean="0"/>
              <a:t>Trp</a:t>
            </a:r>
            <a:r>
              <a:rPr lang="de-DE" sz="1400" dirty="0" smtClean="0"/>
              <a:t>. </a:t>
            </a:r>
            <a:r>
              <a:rPr lang="de-DE" sz="1400" dirty="0" err="1" smtClean="0"/>
              <a:t>Landy</a:t>
            </a:r>
            <a:r>
              <a:rPr lang="de-DE" sz="1400" dirty="0" smtClean="0"/>
              <a:t>: medium </a:t>
            </a:r>
            <a:r>
              <a:rPr lang="de-DE" sz="1400" dirty="0" err="1" smtClean="0"/>
              <a:t>control</a:t>
            </a:r>
            <a:r>
              <a:rPr lang="de-DE" sz="1400" dirty="0" smtClean="0"/>
              <a:t>.</a:t>
            </a:r>
            <a:endParaRPr lang="de-DE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</Words>
  <Application>Microsoft Office PowerPoint</Application>
  <PresentationFormat>Bildschirmpräsentation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1</dc:creator>
  <cp:lastModifiedBy>borriss1</cp:lastModifiedBy>
  <cp:revision>3</cp:revision>
  <dcterms:created xsi:type="dcterms:W3CDTF">2013-11-27T20:18:14Z</dcterms:created>
  <dcterms:modified xsi:type="dcterms:W3CDTF">2014-05-04T10:40:54Z</dcterms:modified>
</cp:coreProperties>
</file>